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A08416-119B-46DC-82AE-BBB4F2CE2D9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D0757C-5447-4BF5-A9F8-83933E386D7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BB3E80-65A2-486F-81C6-A2CAF57130E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7B0F24-4445-436E-A846-3DD000C18F5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6CD7CD-820C-4F5C-889B-2C125AD37F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9E46B9-7B99-4487-8CA5-4D5253FA66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ED211A-DB4D-4B19-9FCB-F5C30BE564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D388E8-847D-45C4-BD42-3A60C989118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507411-4CD8-4D29-B501-8BDE063E86C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A49D97-EF6A-4896-BE62-DFA9472800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49C331-42C0-4C94-9CF2-51B5449C9B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0401DD-E390-4E66-9BA2-6BA1E0283B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61A2480-6937-4E93-AE9E-AE2930E1744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684360" y="549360"/>
            <a:ext cx="43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8892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opup" descr=""/>
          <p:cNvPicPr/>
          <p:nvPr/>
        </p:nvPicPr>
        <p:blipFill>
          <a:blip r:embed="rId1"/>
          <a:srcRect l="23583" t="3859" r="13918" b="-1276"/>
          <a:stretch/>
        </p:blipFill>
        <p:spPr>
          <a:xfrm>
            <a:off x="684360" y="981000"/>
            <a:ext cx="3816360" cy="180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3" name="popup" descr=""/>
          <p:cNvPicPr/>
          <p:nvPr/>
        </p:nvPicPr>
        <p:blipFill>
          <a:blip r:embed="rId2"/>
          <a:srcRect l="23577" t="3958" r="13918" b="-1375"/>
          <a:stretch/>
        </p:blipFill>
        <p:spPr>
          <a:xfrm>
            <a:off x="684360" y="3429000"/>
            <a:ext cx="3816360" cy="180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4" name=""/>
          <p:cNvSpPr/>
          <p:nvPr/>
        </p:nvSpPr>
        <p:spPr>
          <a:xfrm>
            <a:off x="1979640" y="3573360"/>
            <a:ext cx="1944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L (L.) infantu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flipH="1">
            <a:off x="2314440" y="3712320"/>
            <a:ext cx="256680" cy="381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163600" y="3666960"/>
            <a:ext cx="104760" cy="193680"/>
          </a:xfrm>
          <a:prstGeom prst="rect">
            <a:avLst/>
          </a:prstGeom>
          <a:noFill/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235240" y="4243320"/>
            <a:ext cx="104760" cy="193680"/>
          </a:xfrm>
          <a:prstGeom prst="rect">
            <a:avLst/>
          </a:prstGeom>
          <a:noFill/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 flipH="1">
            <a:off x="2340000" y="4220280"/>
            <a:ext cx="534960" cy="71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340000" y="4102200"/>
            <a:ext cx="1512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ample 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908000" y="4603680"/>
            <a:ext cx="105120" cy="193680"/>
          </a:xfrm>
          <a:prstGeom prst="rect">
            <a:avLst/>
          </a:prstGeom>
          <a:noFill/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187280" y="4365720"/>
            <a:ext cx="648000" cy="287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755640" y="414972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ample 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4932360" y="561960"/>
            <a:ext cx="43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4" name=""/>
          <p:cNvGrpSpPr/>
          <p:nvPr/>
        </p:nvGrpSpPr>
        <p:grpSpPr>
          <a:xfrm>
            <a:off x="611280" y="1152360"/>
            <a:ext cx="3457440" cy="738360"/>
            <a:chOff x="611280" y="1152360"/>
            <a:chExt cx="3457440" cy="738360"/>
          </a:xfrm>
        </p:grpSpPr>
        <p:sp>
          <p:nvSpPr>
            <p:cNvPr id="55" name=""/>
            <p:cNvSpPr/>
            <p:nvPr/>
          </p:nvSpPr>
          <p:spPr>
            <a:xfrm>
              <a:off x="1968480" y="1152360"/>
              <a:ext cx="1944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L (L.) infant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820880" y="1697040"/>
              <a:ext cx="104760" cy="1936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 flipH="1">
              <a:off x="2249640" y="1264680"/>
              <a:ext cx="321480" cy="7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2122560" y="1152360"/>
              <a:ext cx="104760" cy="1936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2027160" y="1628640"/>
              <a:ext cx="104760" cy="1936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1587960" y="1449360"/>
              <a:ext cx="193320" cy="29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611280" y="1268280"/>
              <a:ext cx="1512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Sample 3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 flipH="1">
              <a:off x="2195280" y="1701720"/>
              <a:ext cx="86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2556000" y="1557360"/>
              <a:ext cx="1512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Sample 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4" name=""/>
          <p:cNvGrpSpPr/>
          <p:nvPr/>
        </p:nvGrpSpPr>
        <p:grpSpPr>
          <a:xfrm>
            <a:off x="4896000" y="981000"/>
            <a:ext cx="3816360" cy="1800360"/>
            <a:chOff x="4896000" y="981000"/>
            <a:chExt cx="3816360" cy="1800360"/>
          </a:xfrm>
        </p:grpSpPr>
        <p:grpSp>
          <p:nvGrpSpPr>
            <p:cNvPr id="65" name=""/>
            <p:cNvGrpSpPr/>
            <p:nvPr/>
          </p:nvGrpSpPr>
          <p:grpSpPr>
            <a:xfrm>
              <a:off x="4896000" y="981000"/>
              <a:ext cx="3816360" cy="1800360"/>
              <a:chOff x="4896000" y="981000"/>
              <a:chExt cx="3816360" cy="1800360"/>
            </a:xfrm>
          </p:grpSpPr>
          <p:pic>
            <p:nvPicPr>
              <p:cNvPr id="66" name="popup" descr=""/>
              <p:cNvPicPr/>
              <p:nvPr/>
            </p:nvPicPr>
            <p:blipFill>
              <a:blip r:embed="rId3"/>
              <a:srcRect l="23577" t="4759" r="13918" b="-693"/>
              <a:stretch/>
            </p:blipFill>
            <p:spPr>
              <a:xfrm>
                <a:off x="4896000" y="981000"/>
                <a:ext cx="3816360" cy="180036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67" name=""/>
              <p:cNvSpPr/>
              <p:nvPr/>
            </p:nvSpPr>
            <p:spPr>
              <a:xfrm>
                <a:off x="6309000" y="1236600"/>
                <a:ext cx="1944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L (L.) infantu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 flipH="1">
                <a:off x="6595200" y="1349280"/>
                <a:ext cx="324360" cy="13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480" bIns="-33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6450120" y="1246320"/>
                <a:ext cx="104760" cy="2030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6623280" y="2222640"/>
                <a:ext cx="104760" cy="2016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 flipH="1">
                <a:off x="6748920" y="2324520"/>
                <a:ext cx="324000" cy="11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2" name=""/>
            <p:cNvSpPr/>
            <p:nvPr/>
          </p:nvSpPr>
          <p:spPr>
            <a:xfrm>
              <a:off x="6407280" y="2205000"/>
              <a:ext cx="1944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Sample 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3" name=""/>
          <p:cNvGrpSpPr/>
          <p:nvPr/>
        </p:nvGrpSpPr>
        <p:grpSpPr>
          <a:xfrm>
            <a:off x="4896000" y="3429000"/>
            <a:ext cx="3816360" cy="1800360"/>
            <a:chOff x="4896000" y="3429000"/>
            <a:chExt cx="3816360" cy="1800360"/>
          </a:xfrm>
        </p:grpSpPr>
        <p:pic>
          <p:nvPicPr>
            <p:cNvPr id="74" name="popup" descr=""/>
            <p:cNvPicPr/>
            <p:nvPr/>
          </p:nvPicPr>
          <p:blipFill>
            <a:blip r:embed="rId4"/>
            <a:srcRect l="25106" t="5818" r="12388" b="-168"/>
            <a:stretch/>
          </p:blipFill>
          <p:spPr>
            <a:xfrm>
              <a:off x="4896000" y="3429000"/>
              <a:ext cx="3816360" cy="18003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75" name=""/>
            <p:cNvSpPr/>
            <p:nvPr/>
          </p:nvSpPr>
          <p:spPr>
            <a:xfrm>
              <a:off x="6215400" y="3656160"/>
              <a:ext cx="1944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L (L.) infant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 flipH="1">
              <a:off x="6483960" y="3768120"/>
              <a:ext cx="321480" cy="7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6337440" y="3662280"/>
              <a:ext cx="104760" cy="1936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6289920" y="4653000"/>
              <a:ext cx="1944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Sample 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 flipH="1">
              <a:off x="6688080" y="4765680"/>
              <a:ext cx="322200" cy="7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6561360" y="4653000"/>
              <a:ext cx="104760" cy="1936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1" name=""/>
          <p:cNvSpPr/>
          <p:nvPr/>
        </p:nvSpPr>
        <p:spPr>
          <a:xfrm>
            <a:off x="4957920" y="2997360"/>
            <a:ext cx="43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611280" y="3068640"/>
            <a:ext cx="43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1-05T17:45:21Z</dcterms:created>
  <dc:creator>hp</dc:creator>
  <dc:description/>
  <dc:language>en-US</dc:language>
  <cp:lastModifiedBy>user</cp:lastModifiedBy>
  <dcterms:modified xsi:type="dcterms:W3CDTF">2013-12-11T11:10:23Z</dcterms:modified>
  <cp:revision>30</cp:revision>
  <dc:subject/>
  <dc:title>Diapositiva 1</dc:title>
</cp:coreProperties>
</file>